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embeddings/oleObject2.docx" ContentType="application/vnd.openxmlformats-officedocument.wordprocessingml.document"/>
  <Override PartName="/ppt/embeddings/oleObject3.docx" ContentType="application/vnd.openxmlformats-officedocument.wordprocessingml.document"/>
  <Override PartName="/ppt/media/image1.pct" ContentType="image/x-pict"/>
  <Override PartName="/ppt/media/image2.pct" ContentType="image/x-pict"/>
  <Override PartName="/ppt/media/image3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122D4-07E7-411C-BA6A-87E9845612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EF5A7F-442D-43A7-A2D4-7F2334545A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4FF0D-26D7-4744-B8C0-FA4B38926E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B4A00-E3C2-477F-BE7A-0C2E88E879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B0BAB-A747-4F91-98C9-C66B4D5BAF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3EF16-97A2-4FD8-A0D5-2FA17F7563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9E958-1A7C-420A-B052-73935B0B18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FE21A-C851-4D73-BAC0-E229465926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15F0B-1D56-4EC7-B67F-5A7A28CA01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EEF85-D727-41BB-81E6-D37199038E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06D2A-CCB3-47B5-850F-7A770A185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508CF-C0E1-4A1B-BC52-F224D551EF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13E429-0823-48AC-B8D4-F9629A49149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ct"/><Relationship Id="rId3" Type="http://schemas.openxmlformats.org/officeDocument/2006/relationships/package" Target="../embeddings/oleObject2.docx"/><Relationship Id="rId4" Type="http://schemas.openxmlformats.org/officeDocument/2006/relationships/image" Target="../media/image2.pct"/><Relationship Id="rId5" Type="http://schemas.openxmlformats.org/officeDocument/2006/relationships/package" Target="../embeddings/oleObject3.docx"/><Relationship Id="rId6" Type="http://schemas.openxmlformats.org/officeDocument/2006/relationships/image" Target="../media/image3.pct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1040" y="1600200"/>
            <a:ext cx="873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: Protein sequence alignments of Mhy1I subunits from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P.abyss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PAB1398.2n)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T.gammatoleran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tg0241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T.onnure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TON_0273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311400" y="3581280"/>
            <a:ext cx="844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: Protein sequence alignment of Mhy2I subunits from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T.litoral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TlMhyI)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T.gammatoleran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tg0056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T.onnure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TON_1572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7542720" y="6324480"/>
            <a:ext cx="1180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1371600" y="2133720"/>
          <a:ext cx="6858000" cy="13525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71600" y="2133720"/>
                    <a:ext cx="6858000" cy="135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1371600" y="152280"/>
          <a:ext cx="6781680" cy="1486080"/>
        </p:xfrm>
        <a:graphic>
          <a:graphicData uri="http://schemas.openxmlformats.org/presentationml/2006/ole">
            <p:oleObj progId="Word.Document.12"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371600" y="152280"/>
                    <a:ext cx="6781680" cy="1486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"/>
          <p:cNvGraphicFramePr/>
          <p:nvPr/>
        </p:nvGraphicFramePr>
        <p:xfrm>
          <a:off x="1219320" y="3962520"/>
          <a:ext cx="6400800" cy="2103480"/>
        </p:xfrm>
        <a:graphic>
          <a:graphicData uri="http://schemas.openxmlformats.org/presentationml/2006/ole">
            <p:oleObj progId="Word.Document.12" r:id="rId5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219320" y="3962520"/>
                    <a:ext cx="6400800" cy="210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386640" y="6172200"/>
            <a:ext cx="35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: Protein sequence alignment of the six MhyI subunit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35680" y="6094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35320" y="24382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35320" y="45720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1T19:00:09Z</dcterms:created>
  <dc:creator>fabrice confalonieri</dc:creator>
  <dc:description/>
  <dc:language>en-US</dc:language>
  <cp:lastModifiedBy>fabrice confalonieri</cp:lastModifiedBy>
  <dcterms:modified xsi:type="dcterms:W3CDTF">2009-03-23T21:11:05Z</dcterms:modified>
  <cp:revision>4</cp:revision>
  <dc:subject/>
  <dc:title>Présentation PowerPoint</dc:title>
</cp:coreProperties>
</file>